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350" r:id="rId6"/>
    <p:sldId id="339" r:id="rId7"/>
    <p:sldId id="347" r:id="rId8"/>
    <p:sldId id="348" r:id="rId9"/>
    <p:sldId id="349" r:id="rId10"/>
    <p:sldId id="343" r:id="rId11"/>
    <p:sldId id="344" r:id="rId12"/>
    <p:sldId id="345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04" userDrawn="1">
          <p15:clr>
            <a:srgbClr val="A4A3A4"/>
          </p15:clr>
        </p15:guide>
        <p15:guide id="2" pos="3114" userDrawn="1">
          <p15:clr>
            <a:srgbClr val="A4A3A4"/>
          </p15:clr>
        </p15:guide>
        <p15:guide id="3" pos="960" userDrawn="1">
          <p15:clr>
            <a:srgbClr val="A4A3A4"/>
          </p15:clr>
        </p15:guide>
        <p15:guide id="4" pos="1345" userDrawn="1">
          <p15:clr>
            <a:srgbClr val="A4A3A4"/>
          </p15:clr>
        </p15:guide>
        <p15:guide id="5" orient="horz" pos="1253" userDrawn="1">
          <p15:clr>
            <a:srgbClr val="A4A3A4"/>
          </p15:clr>
        </p15:guide>
        <p15:guide id="6" orient="horz" pos="845" userDrawn="1">
          <p15:clr>
            <a:srgbClr val="A4A3A4"/>
          </p15:clr>
        </p15:guide>
        <p15:guide id="7" pos="45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366" autoAdjust="0"/>
    <p:restoredTop sz="94615"/>
  </p:normalViewPr>
  <p:slideViewPr>
    <p:cSldViewPr snapToGrid="0">
      <p:cViewPr varScale="1">
        <p:scale>
          <a:sx n="106" d="100"/>
          <a:sy n="106" d="100"/>
        </p:scale>
        <p:origin x="808" y="176"/>
      </p:cViewPr>
      <p:guideLst>
        <p:guide orient="horz" pos="2704"/>
        <p:guide pos="3114"/>
        <p:guide pos="960"/>
        <p:guide pos="1345"/>
        <p:guide orient="horz" pos="1253"/>
        <p:guide orient="horz" pos="845"/>
        <p:guide pos="454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ar\folders\q5\5mxdmyjx3019brk8pms8t_600000gp\T\com.microsoft.Outlook\Outlook%20Temp\il6%20sf3b1%20qpcr%5b2%5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var\folders\q5\5mxdmyjx3019brk8pms8t_600000gp\T\com.microsoft.Outlook\Outlook%20Temp\il6%20sf3b1%20qpcr%5b2%5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f3B1 - IL6 6 hrs'!$N$2:$N$4</c:f>
                <c:numCache>
                  <c:formatCode>General</c:formatCode>
                  <c:ptCount val="3"/>
                  <c:pt idx="0">
                    <c:v>7.0295314609243736E-2</c:v>
                  </c:pt>
                  <c:pt idx="1">
                    <c:v>0.12207150446709709</c:v>
                  </c:pt>
                  <c:pt idx="2">
                    <c:v>0.13032575851448727</c:v>
                  </c:pt>
                </c:numCache>
              </c:numRef>
            </c:plus>
            <c:minus>
              <c:numRef>
                <c:f>'Sf3B1 - IL6 6 hrs'!$N$2:$N$4</c:f>
                <c:numCache>
                  <c:formatCode>General</c:formatCode>
                  <c:ptCount val="3"/>
                  <c:pt idx="0">
                    <c:v>7.0295314609243736E-2</c:v>
                  </c:pt>
                  <c:pt idx="1">
                    <c:v>0.12207150446709709</c:v>
                  </c:pt>
                  <c:pt idx="2">
                    <c:v>0.130325758514487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f3B1 - IL6 6 hrs'!$K$2:$K$4</c:f>
              <c:strCache>
                <c:ptCount val="3"/>
                <c:pt idx="0">
                  <c:v>0 ng/ml</c:v>
                </c:pt>
                <c:pt idx="1">
                  <c:v>1 ng/ml</c:v>
                </c:pt>
                <c:pt idx="2">
                  <c:v>25 ng/ml</c:v>
                </c:pt>
              </c:strCache>
            </c:strRef>
          </c:cat>
          <c:val>
            <c:numRef>
              <c:f>'Sf3B1 - IL6 6 hrs'!$L$2:$L$4</c:f>
              <c:numCache>
                <c:formatCode>General</c:formatCode>
                <c:ptCount val="3"/>
                <c:pt idx="0">
                  <c:v>1</c:v>
                </c:pt>
                <c:pt idx="1">
                  <c:v>0.73792719048539368</c:v>
                </c:pt>
                <c:pt idx="2">
                  <c:v>0.830210408121951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23-524D-A356-CB903DD283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4211384"/>
        <c:axId val="544208640"/>
      </c:barChart>
      <c:catAx>
        <c:axId val="544211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208640"/>
        <c:crosses val="autoZero"/>
        <c:auto val="1"/>
        <c:lblAlgn val="ctr"/>
        <c:lblOffset val="100"/>
        <c:noMultiLvlLbl val="0"/>
      </c:catAx>
      <c:valAx>
        <c:axId val="54420864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211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aseline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f3B1 - IL6 6 hrs'!$N$2:$N$4</c:f>
                <c:numCache>
                  <c:formatCode>General</c:formatCode>
                  <c:ptCount val="3"/>
                  <c:pt idx="0">
                    <c:v>7.0295314609243736E-2</c:v>
                  </c:pt>
                  <c:pt idx="1">
                    <c:v>0.12207150446709709</c:v>
                  </c:pt>
                  <c:pt idx="2">
                    <c:v>0.13032575851448727</c:v>
                  </c:pt>
                </c:numCache>
              </c:numRef>
            </c:plus>
            <c:minus>
              <c:numRef>
                <c:f>'Sf3B1 - IL6 6 hrs'!$N$2:$N$4</c:f>
                <c:numCache>
                  <c:formatCode>General</c:formatCode>
                  <c:ptCount val="3"/>
                  <c:pt idx="0">
                    <c:v>7.0295314609243736E-2</c:v>
                  </c:pt>
                  <c:pt idx="1">
                    <c:v>0.12207150446709709</c:v>
                  </c:pt>
                  <c:pt idx="2">
                    <c:v>0.130325758514487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f3B1 - IL6 24 hours'!$K$2:$K$4</c:f>
              <c:strCache>
                <c:ptCount val="3"/>
                <c:pt idx="0">
                  <c:v>0 ng/ml</c:v>
                </c:pt>
                <c:pt idx="1">
                  <c:v>1 ng/ml</c:v>
                </c:pt>
                <c:pt idx="2">
                  <c:v>25 ng/ml</c:v>
                </c:pt>
              </c:strCache>
            </c:strRef>
          </c:cat>
          <c:val>
            <c:numRef>
              <c:f>'Sf3B1 - IL6 24 hours'!$L$2:$L$4</c:f>
              <c:numCache>
                <c:formatCode>General</c:formatCode>
                <c:ptCount val="3"/>
                <c:pt idx="0">
                  <c:v>1</c:v>
                </c:pt>
                <c:pt idx="1">
                  <c:v>0.8469635992601473</c:v>
                </c:pt>
                <c:pt idx="2">
                  <c:v>1.21208658142777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BA-AC4E-BD0D-07DF3EEF45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4209032"/>
        <c:axId val="544210600"/>
      </c:barChart>
      <c:catAx>
        <c:axId val="544209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210600"/>
        <c:crosses val="autoZero"/>
        <c:auto val="1"/>
        <c:lblAlgn val="ctr"/>
        <c:lblOffset val="100"/>
        <c:noMultiLvlLbl val="0"/>
      </c:catAx>
      <c:valAx>
        <c:axId val="54421060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209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aseline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3E397-8DE7-0DAE-ACC7-AC63449714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EA8EA38-CCBD-9BCE-0B23-AC7598B9C7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5211D2-686D-293D-DBAA-B33698D2E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7CFF1-ECA1-7075-2828-00D81A834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4D26F6-20AC-8D25-C063-D7A4D075F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794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9427A-511C-3962-7048-F2FFAAC0A2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38F284-ECF9-9030-083D-345E011602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612F21-0757-4DD8-C1C3-805696F3A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05F456-3EDA-CE4F-13A4-E1762802C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BD7EAA-A7B5-AF82-CD28-1CA5C8B13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42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106349-C1D8-5425-BE43-9D4FF7A7EF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7EA7F0-F568-7401-C416-EA16BA66BC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4C9265-E838-C969-2879-6BA3544C6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8561A4-0348-B209-DAC8-EBBA3E04B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410DE-31B1-CC5C-4765-EB5BAD471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677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BA99A-FD1F-E837-DC8C-BA44310FC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A44863-A9C3-3C87-9837-F450F50ECE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B699A7-319E-6F1D-6C73-BE78F98BD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E4F66-4F5C-C524-906A-FFB07B9FC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12192F-A4B9-7B22-88B5-A98FF859A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73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53075-C0C8-38D0-E87F-18552FC41E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ECDDF9-2B0D-D663-EABF-7CFD2E2FAC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4C9B5A-CA12-2D19-93BB-939267678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794712-4BE7-D177-D0BD-6C93BFF4B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92961C-52C0-03DB-979C-04C9C8FEB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975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5D1404-9102-A7DC-0390-46F8AE85AB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4FA9E3-BE5E-BA68-FBE6-48EA9F1212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F6B0EB-83DE-0384-3215-07C81BBCA0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DF29D7-B2DE-7EF4-8D5C-2976F83C7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4FF56C-A00B-8CD2-924D-E09227403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1B15A5-ED40-D824-E097-0E5211217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32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A8C5D-A750-50B0-2A13-D95FAB04DE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3FE800-937B-B8AE-6DDA-163BE1C053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1D0ED5-DD20-488A-3317-01FF1A1CAA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497FD7-5A7A-7799-B44C-F8FD880532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21AD7C-EEC3-8D17-47BB-3AB0228F9E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5B6594-7E4B-569A-E5D8-2F1785857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3C5FD6-3660-4944-50BB-597742348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7756A5-1166-8828-418C-0FA1F0B81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804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ACFCD-7E3B-E3F4-4DBE-7DA7E64D6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1ECB91-78D3-58B0-D6B9-FD05E98B6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E427A7-7901-E879-51CE-06EE5B1D4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4D2FA4-4DE5-0A8D-CCD6-C5E8C01ED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631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F9B371A-5D50-12AF-4811-13E08B6EF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F65B35-A9E4-C635-A552-514844ADE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B60B84-B757-3589-926C-37B6F1F27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94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530ABD-8868-A206-859B-74A8DD3A74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2EF4D2-8446-3B99-D904-DBDB35E616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AA41FC-D8DB-BBB2-3321-2C29414F7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7DA995-0EFF-D78E-ABE0-25670FB12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98744F-3629-E487-1ED7-DF0449FD8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DB7BFE-7F7E-59B3-9223-07B4BC256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52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795FB-2281-AB69-C955-2DDF6A868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0D4253-CF4C-7CF0-0DA0-35BC63FD96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031B71-8A6F-001D-40FB-59B3467276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B9D11F-3859-9C8F-52A0-75D86DBC0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93566C-4637-7FE2-8BE7-1C138DDDE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304BF4-1E0E-E95B-581B-BC2BC6969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324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B14B5C-FA69-6F42-0838-641F6BFF94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0967D2-C35F-86B4-C000-09BE654394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798EC-0FDB-E55B-759C-101CD599BF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2660C3-40D5-D34D-BF16-95628233BB71}" type="datetimeFigureOut">
              <a:rPr lang="en-US" smtClean="0"/>
              <a:t>1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F8407-6D9B-8D08-8BEF-6968FB83CE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8F4BF5-4DDA-6281-118C-D8911075BB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013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JP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emf"/><Relationship Id="rId4" Type="http://schemas.openxmlformats.org/officeDocument/2006/relationships/oleObject" Target="../embeddings/oleObject6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emf"/><Relationship Id="rId4" Type="http://schemas.openxmlformats.org/officeDocument/2006/relationships/oleObject" Target="../embeddings/oleObject8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0B013FC-FFBE-5D8E-FBBD-CB30A14839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3472" y="1194050"/>
            <a:ext cx="4853412" cy="2234950"/>
          </a:xfrm>
          <a:prstGeom prst="rect">
            <a:avLst/>
          </a:prstGeom>
        </p:spPr>
      </p:pic>
      <p:sp>
        <p:nvSpPr>
          <p:cNvPr id="5" name="Rectangle 2">
            <a:extLst>
              <a:ext uri="{FF2B5EF4-FFF2-40B4-BE49-F238E27FC236}">
                <a16:creationId xmlns:a16="http://schemas.microsoft.com/office/drawing/2014/main" id="{20CA3CFD-978C-148C-FF23-6FD45C84E4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5200" y="60157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F7D02B-C4D0-6F77-56CF-B828A02ECF15}"/>
              </a:ext>
            </a:extLst>
          </p:cNvPr>
          <p:cNvSpPr txBox="1"/>
          <p:nvPr/>
        </p:nvSpPr>
        <p:spPr>
          <a:xfrm>
            <a:off x="782052" y="4740620"/>
            <a:ext cx="10627896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scillating high glucose significantly increases </a:t>
            </a:r>
            <a:r>
              <a:rPr lang="en-GB" sz="1200" b="1" dirty="0" err="1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cl-xS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</a:t>
            </a:r>
            <a:r>
              <a:rPr lang="en-GB" sz="1200" b="1" dirty="0" err="1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cl-xL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atio. </a:t>
            </a:r>
          </a:p>
          <a:p>
            <a:pPr algn="just">
              <a:lnSpc>
                <a:spcPct val="150000"/>
              </a:lnSpc>
            </a:pP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T-PCR samples from HEK293 cells treated with Normal glucose (5.5 mM)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Mannitol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Oscillating Mannitol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High Glucose (25mM)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r Oscillating high glucose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H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for 48 hrs were run on the bioanalyzer. Oscillating treatment involves changing media from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o either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G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ack and forth every 12 hrs till 48 hrs is reached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bioanalyzer gel image.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quantification of bioanalyzer concentrations showed a significant increase between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H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mean=2.04,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0.28 SEM, ****p&lt;0.0001,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=4 repeats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US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 between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H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mean=1.10,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0.05 SEM, ***p=0.0005,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=4 repeats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ere analysed using ordinary one-way ANOVA with a multiple comparison post hoc analysis.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GB" sz="1200" dirty="0">
              <a:solidFill>
                <a:srgbClr val="0D0D0D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138CFAA-7A2B-B957-0620-215B68FA6384}"/>
              </a:ext>
            </a:extLst>
          </p:cNvPr>
          <p:cNvSpPr txBox="1"/>
          <p:nvPr/>
        </p:nvSpPr>
        <p:spPr>
          <a:xfrm>
            <a:off x="973472" y="7820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6981DB-EE08-3AA4-680F-4386B19F3597}"/>
              </a:ext>
            </a:extLst>
          </p:cNvPr>
          <p:cNvSpPr txBox="1"/>
          <p:nvPr/>
        </p:nvSpPr>
        <p:spPr>
          <a:xfrm>
            <a:off x="6772693" y="774396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6385485"/>
              </p:ext>
            </p:extLst>
          </p:nvPr>
        </p:nvGraphicFramePr>
        <p:xfrm>
          <a:off x="7753350" y="514351"/>
          <a:ext cx="3225800" cy="38015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907376" imgH="3390850" progId="Prism10.Document">
                  <p:embed/>
                </p:oleObj>
              </mc:Choice>
              <mc:Fallback>
                <p:oleObj name="Prism 10" r:id="rId3" imgW="2907376" imgH="339085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753350" y="514351"/>
                        <a:ext cx="3225800" cy="38015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097084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006579"/>
            <a:ext cx="10627896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der has on significant influence o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ratio obtained from urine sediment samples: cDNA was obtained from RNA, extracted from overnight urine sample sediments.. RTPCR was perform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quantify isoform concentration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calculated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ratio was plotted based on patient’s gender. The data was statisticall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a Mann-Whitney test. (mean= 2.52; ns p=0.747; N=15 patients; SEM ±0.501); Female (mean= 2.15; ns p=0.747; N=14 patients; SEM ±0.388).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re is no significant difference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ratio obtained from leucocytes between males and females: cDNA was obtained from RNA, extracted from leucocytes from blood samples. RTPCR was perform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quantify isoform concentration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calculated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ratio was plotted based on patient’s gender. The data was statisticall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a Mann-Whitney test. Male (mean= 2.78; ns p=0.453; N=30 patients; SEM ±0.512); Female (mean= 2.32; ns p=0.453; N=1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atein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SEM ±0.592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973472" y="7820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6096000" y="840818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275E3C63-25BE-05B8-33AA-D8AF863E6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831" y="9384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CD407350-9602-BF5E-3FDB-F818E1421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377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BAF5A66-B6AC-AFE9-4058-639C31A69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9578" y="103610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8" name="Rectangle 4">
            <a:extLst>
              <a:ext uri="{FF2B5EF4-FFF2-40B4-BE49-F238E27FC236}">
                <a16:creationId xmlns:a16="http://schemas.microsoft.com/office/drawing/2014/main" id="{7E483F17-FABD-83C4-453E-664DF605C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4601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30399" y="1106905"/>
            <a:ext cx="2180403" cy="264681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1712" y="1144989"/>
            <a:ext cx="2189925" cy="257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77417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006579"/>
            <a:ext cx="1062789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1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i. IL-6 increases the pro-apoptotic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band intensity in a concentration-dependent manner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 cells were treated with or without recombinant human IL-6 at concentrations 0 ng, 0.1 ng, 1 ng, 10 ng, 25 ng or 50 ng and RNA was extracted after 48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made into cDNA and RT-PCR performed f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x isoforms.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ii. IL-6 increases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ratio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nds from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i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analyzed by densitometry using image j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IL-6 increases apoptosis in a dose-wise manner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 cells were treated with or without recombinant human IL-6 at concentrations 0 ng, 0.1 ng, 1 ng, 10 ng, 25 ng or 50 ng and a JC-10 assay was performed after 24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reatment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rapt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presents a ratio of apoptotic cells (green) to normal cells (red). 0.1 ng/ml (mean=1.75, ±0.27 SEM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s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0.092, N=17 repeats), 1 ng/ml (mean=2.03, ±0.37 SEM, *p=0.028, N=18 repeats), 10 ng/ml (mean=2.38, ±0.37 SEM, ***p=0.0009, N=16 repeats), 25 ng/ml (mean=2.23, ±0.42 SEM, **p=0.007, N=15 repeats) and 50 ng/ml (mean=3.23, ±0.53 SEM, ****p&lt;0.0001, N=18 repeats). Data were statisticall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sing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rusk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Wallis test and a multiple comparison post-hoc analysis</a:t>
            </a:r>
          </a:p>
          <a:p>
            <a:pPr marL="228600" indent="-228600" algn="just">
              <a:buAutoNum type="alphaUcPeriod"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4589671" y="75379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ii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275E3C63-25BE-05B8-33AA-D8AF863E6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831" y="9384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CD407350-9602-BF5E-3FDB-F818E1421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377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BAF5A66-B6AC-AFE9-4058-639C31A69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9578" y="103610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8" name="Rectangle 4">
            <a:extLst>
              <a:ext uri="{FF2B5EF4-FFF2-40B4-BE49-F238E27FC236}">
                <a16:creationId xmlns:a16="http://schemas.microsoft.com/office/drawing/2014/main" id="{7E483F17-FABD-83C4-453E-664DF605C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4601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2" name="Rectangle 2">
            <a:extLst>
              <a:ext uri="{FF2B5EF4-FFF2-40B4-BE49-F238E27FC236}">
                <a16:creationId xmlns:a16="http://schemas.microsoft.com/office/drawing/2014/main" id="{8EA54945-96D1-86F6-2212-80589EB9FA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5654" y="550111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6224A7EC-EA2B-59A0-1AF3-3246009FFE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583053"/>
              </p:ext>
            </p:extLst>
          </p:nvPr>
        </p:nvGraphicFramePr>
        <p:xfrm>
          <a:off x="8713788" y="285750"/>
          <a:ext cx="2978150" cy="3711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977602" imgH="3711027" progId="Prism9.Document">
                  <p:embed/>
                </p:oleObj>
              </mc:Choice>
              <mc:Fallback>
                <p:oleObj name="Prism 9" r:id="rId2" imgW="2977602" imgH="3711027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713788" y="285750"/>
                        <a:ext cx="2978150" cy="37115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424019CE-31BF-0C72-D085-ED08B2D4FCA5}"/>
              </a:ext>
            </a:extLst>
          </p:cNvPr>
          <p:cNvSpPr txBox="1"/>
          <p:nvPr/>
        </p:nvSpPr>
        <p:spPr>
          <a:xfrm>
            <a:off x="5310869" y="-7070"/>
            <a:ext cx="979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EK-293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50FA5357-CFD3-6854-DA3A-C90CE8DA51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09556" y="838019"/>
            <a:ext cx="2953387" cy="309131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03ECBB58-7B3F-DC7E-27CA-B33E193A84F9}"/>
              </a:ext>
            </a:extLst>
          </p:cNvPr>
          <p:cNvSpPr txBox="1"/>
          <p:nvPr/>
        </p:nvSpPr>
        <p:spPr>
          <a:xfrm>
            <a:off x="8513860" y="7185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529" y="831886"/>
            <a:ext cx="3952028" cy="2619187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56084" y="75379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i. </a:t>
            </a:r>
          </a:p>
        </p:txBody>
      </p:sp>
    </p:spTree>
    <p:extLst>
      <p:ext uri="{BB962C8B-B14F-4D97-AF65-F5344CB8AC3E}">
        <p14:creationId xmlns:p14="http://schemas.microsoft.com/office/powerpoint/2010/main" val="339439812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006579"/>
            <a:ext cx="106278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2. SF3B1 expression is not regulated by IL-6 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EnC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EnC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ere treated for 6 h (A) and 24 h (B) with 0, 1, or 25 ng/ml IL-6. There was no significant change in the mRNA expression of SF3B1 after either 6 or 24 h in response to IL-6 treatment (n=3; p=ns as assessed by Kruskal-Wallis)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973472" y="7820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7014829" y="85144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275E3C63-25BE-05B8-33AA-D8AF863E6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831" y="9384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CD407350-9602-BF5E-3FDB-F818E1421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377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BAF5A66-B6AC-AFE9-4058-639C31A69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9578" y="103610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8" name="Rectangle 4">
            <a:extLst>
              <a:ext uri="{FF2B5EF4-FFF2-40B4-BE49-F238E27FC236}">
                <a16:creationId xmlns:a16="http://schemas.microsoft.com/office/drawing/2014/main" id="{7E483F17-FABD-83C4-453E-664DF605C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4601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2" name="Rectangle 2">
            <a:extLst>
              <a:ext uri="{FF2B5EF4-FFF2-40B4-BE49-F238E27FC236}">
                <a16:creationId xmlns:a16="http://schemas.microsoft.com/office/drawing/2014/main" id="{8EA54945-96D1-86F6-2212-80589EB9FA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5654" y="550111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61A1CD0D-E526-CA4E-52EA-F3AB17880F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5885376"/>
              </p:ext>
            </p:extLst>
          </p:nvPr>
        </p:nvGraphicFramePr>
        <p:xfrm>
          <a:off x="2208810" y="1272713"/>
          <a:ext cx="3276931" cy="19550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B797F093-339B-A3F8-7542-769FA3361A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7681645"/>
              </p:ext>
            </p:extLst>
          </p:nvPr>
        </p:nvGraphicFramePr>
        <p:xfrm>
          <a:off x="8151284" y="1048483"/>
          <a:ext cx="3067244" cy="23571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43EA4206-6C63-EA45-8623-00B57A6687E8}"/>
              </a:ext>
            </a:extLst>
          </p:cNvPr>
          <p:cNvSpPr txBox="1"/>
          <p:nvPr/>
        </p:nvSpPr>
        <p:spPr>
          <a:xfrm rot="16200000">
            <a:off x="757340" y="2149891"/>
            <a:ext cx="177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F3B1 relative expression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4E125C4-C041-674B-EFCB-4DA5FAE45441}"/>
              </a:ext>
            </a:extLst>
          </p:cNvPr>
          <p:cNvSpPr txBox="1"/>
          <p:nvPr/>
        </p:nvSpPr>
        <p:spPr>
          <a:xfrm rot="16200000">
            <a:off x="6833877" y="2035102"/>
            <a:ext cx="177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F3B1 relative expression </a:t>
            </a:r>
          </a:p>
        </p:txBody>
      </p:sp>
    </p:spTree>
    <p:extLst>
      <p:ext uri="{BB962C8B-B14F-4D97-AF65-F5344CB8AC3E}">
        <p14:creationId xmlns:p14="http://schemas.microsoft.com/office/powerpoint/2010/main" val="3219659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6A8F55EF-5B90-B0B2-6733-F23871CE41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1526" y="43313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FE47FD-4B0B-E066-E64D-5CC0F8670B7C}"/>
              </a:ext>
            </a:extLst>
          </p:cNvPr>
          <p:cNvSpPr txBox="1"/>
          <p:nvPr/>
        </p:nvSpPr>
        <p:spPr>
          <a:xfrm>
            <a:off x="782052" y="5039868"/>
            <a:ext cx="106278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scillating high glucos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treatment increases apoptosis in HEK293 cells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 cells were treated with Normal glucose NG (5.5mM), Mannitol M, Oscillating Mannitol OM, High Glucose (25mM) HG and Oscillating High Glucose OHG for 48 hrs. A JC-10 assay was performed after the 48hours to assess apoptosis. The graph represents a ratio of apoptotic cells (green) to normal cells (red).  Statistical analysis was performed using an ordinary one-way ANOVA. Statistically significant increase in apoptosis for the pairwise analysis between NG and OHG (mean=1.30, ±0.061 SEM, *p=0.031, N=10 repeats), HG and OHG (mean=1.30, ±0.061 SEM, **p=0.037, N=10 repeats) and OM and OHG (mean=1.30, ±0.061 SEM, **p=0.047, N=10 repeats).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5301746"/>
              </p:ext>
            </p:extLst>
          </p:nvPr>
        </p:nvGraphicFramePr>
        <p:xfrm>
          <a:off x="3946903" y="286604"/>
          <a:ext cx="3791378" cy="44884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87443" imgH="3569127" progId="Prism10.Document">
                  <p:embed/>
                </p:oleObj>
              </mc:Choice>
              <mc:Fallback>
                <p:oleObj name="Prism 10" r:id="rId2" imgW="3087443" imgH="356912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46903" y="286604"/>
                        <a:ext cx="3791378" cy="44884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755095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>
            <a:extLst>
              <a:ext uri="{FF2B5EF4-FFF2-40B4-BE49-F238E27FC236}">
                <a16:creationId xmlns:a16="http://schemas.microsoft.com/office/drawing/2014/main" id="{20CA3CFD-978C-148C-FF23-6FD45C84E4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5200" y="60157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F7D02B-C4D0-6F77-56CF-B828A02ECF15}"/>
              </a:ext>
            </a:extLst>
          </p:cNvPr>
          <p:cNvSpPr txBox="1"/>
          <p:nvPr/>
        </p:nvSpPr>
        <p:spPr>
          <a:xfrm>
            <a:off x="782052" y="4740620"/>
            <a:ext cx="106278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Glucose soup, but not oscillating glucose soup significantly increases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ratio.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T-PCR samples from HEK293 cells treated with Normal glucose (5.5 mM) NG, Mannitol M, Oscillating Mannitol OM, Glucose Soup (25 mM with TNF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g/ml, IL-6 1ng/ml and insulin 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) GS+ or Oscillating glucose soup OGS+ for 48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ere run on the bioanalyzer. Oscillating treatment involves changing media from NG to either M or GS+ back and forth every 12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ill 48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s reached A. bioanalyzer gel image. B. quantification of bioanalyzer concentrations showed a significant increase between NG and GS+ (mean=1.89, ±0.28 SEM, *p&lt;0.025, N=4 repeats) and between M and GS+ (mean=1.01, ±0.13 SEM, *p=0.027, N=4 repeats). Data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sing ordinary one-way ANOVA with a multiple comparison post hoc analysis. 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138CFAA-7A2B-B957-0620-215B68FA6384}"/>
              </a:ext>
            </a:extLst>
          </p:cNvPr>
          <p:cNvSpPr txBox="1"/>
          <p:nvPr/>
        </p:nvSpPr>
        <p:spPr>
          <a:xfrm>
            <a:off x="973472" y="7820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6981DB-EE08-3AA4-680F-4386B19F3597}"/>
              </a:ext>
            </a:extLst>
          </p:cNvPr>
          <p:cNvSpPr txBox="1"/>
          <p:nvPr/>
        </p:nvSpPr>
        <p:spPr>
          <a:xfrm>
            <a:off x="6772693" y="774396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498A395-3CF3-69FB-FE83-0F9E522B12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4274" y="78205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2269804"/>
              </p:ext>
            </p:extLst>
          </p:nvPr>
        </p:nvGraphicFramePr>
        <p:xfrm>
          <a:off x="7769765" y="601579"/>
          <a:ext cx="3206435" cy="37113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907376" imgH="3323862" progId="Prism10.Document">
                  <p:embed/>
                </p:oleObj>
              </mc:Choice>
              <mc:Fallback>
                <p:oleObj name="Prism 10" r:id="rId2" imgW="2907376" imgH="332386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769765" y="601579"/>
                        <a:ext cx="3206435" cy="37113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6" name="Group 15"/>
          <p:cNvGrpSpPr/>
          <p:nvPr/>
        </p:nvGrpSpPr>
        <p:grpSpPr>
          <a:xfrm>
            <a:off x="973472" y="1151385"/>
            <a:ext cx="4895065" cy="2277615"/>
            <a:chOff x="973472" y="1337510"/>
            <a:chExt cx="4683125" cy="22098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E2CCE79-862E-B362-00BC-8722B0AE80B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3472" y="1337510"/>
              <a:ext cx="4683125" cy="2209800"/>
            </a:xfrm>
            <a:prstGeom prst="rect">
              <a:avLst/>
            </a:prstGeom>
            <a:noFill/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37" t="49970" r="465" b="14663"/>
            <a:stretch/>
          </p:blipFill>
          <p:spPr>
            <a:xfrm>
              <a:off x="2876550" y="2311400"/>
              <a:ext cx="2657475" cy="117157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158737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6A8F55EF-5B90-B0B2-6733-F23871CE41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1526" y="43313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FE47FD-4B0B-E066-E64D-5CC0F8670B7C}"/>
              </a:ext>
            </a:extLst>
          </p:cNvPr>
          <p:cNvSpPr txBox="1"/>
          <p:nvPr/>
        </p:nvSpPr>
        <p:spPr>
          <a:xfrm>
            <a:off x="782052" y="4740620"/>
            <a:ext cx="1062789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Glucose soup but not oscillating glucose soup treatment increase apoptosis in HEK293 cells.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 cells were treated with Normal glucose NG (5.5mM), Mannitol M, Oscillating Mannitol OM, Glucose soup (25mM) GS+ and Oscillating Glucose Soup OGS+ for 48 hrs. A JC-10 assay was performed after the 48hours to assess apoptosi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rapt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presents a ratio of apoptotic cells (green) to normal cells (red).  Statistical analysis was performed using an ordinary one-way ANOVA. A statistically significant increase in apoptosis was seen in the pairwise analysis between NG and GS+ (mean=2.98, ±0.33 SEM, ****p&lt;0.0001, N=17 repeats), M and GS+ (mean=2.98, ±0.33 SEM, ****p&lt;0.0001, N=17 repeats) as well as between GS+ and OGS+ (mean=2.98, ±0.33 SEM, **p=0.005, N=17 repeats).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B816FF81-9E6F-088C-4E1B-792178FC94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6515" y="154895"/>
            <a:ext cx="15417848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8803719"/>
              </p:ext>
            </p:extLst>
          </p:nvPr>
        </p:nvGraphicFramePr>
        <p:xfrm>
          <a:off x="4102100" y="433388"/>
          <a:ext cx="3686175" cy="4306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968239" imgH="3515824" progId="Prism10.Document">
                  <p:embed/>
                </p:oleObj>
              </mc:Choice>
              <mc:Fallback>
                <p:oleObj name="Prism 10" r:id="rId2" imgW="2968239" imgH="351582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02100" y="433388"/>
                        <a:ext cx="3686175" cy="4306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577802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4628094-816A-224E-BC2D-BBD828CF17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4039" y="711199"/>
            <a:ext cx="5179967" cy="455501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FF4A0D3-DFC8-7F07-E4F1-C57BB6ACCD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0555" y="5650928"/>
            <a:ext cx="9150889" cy="749873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A06A035-2DF2-B7E5-1B26-815F0D2453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2433" y="434200"/>
            <a:ext cx="4739824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                                              24 hours                             48hours 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65220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2CA281A-A763-D41B-0E77-32A007F23563}"/>
              </a:ext>
            </a:extLst>
          </p:cNvPr>
          <p:cNvGrpSpPr/>
          <p:nvPr/>
        </p:nvGrpSpPr>
        <p:grpSpPr>
          <a:xfrm>
            <a:off x="2320714" y="1888846"/>
            <a:ext cx="7550572" cy="995558"/>
            <a:chOff x="2423592" y="4078593"/>
            <a:chExt cx="7550572" cy="995558"/>
          </a:xfrm>
        </p:grpSpPr>
        <p:sp>
          <p:nvSpPr>
            <p:cNvPr id="8" name="TextBox 29">
              <a:extLst>
                <a:ext uri="{FF2B5EF4-FFF2-40B4-BE49-F238E27FC236}">
                  <a16:creationId xmlns:a16="http://schemas.microsoft.com/office/drawing/2014/main" id="{0BB775A6-5AE3-8714-FAC3-8EF3AF83BB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88289" y="4257635"/>
              <a:ext cx="1285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7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684213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3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39825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9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597025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2638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098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670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42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14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cl-xL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29">
              <a:extLst>
                <a:ext uri="{FF2B5EF4-FFF2-40B4-BE49-F238E27FC236}">
                  <a16:creationId xmlns:a16="http://schemas.microsoft.com/office/drawing/2014/main" id="{E626DD58-2C35-9942-71A9-0349661379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88289" y="4653137"/>
              <a:ext cx="1285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7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684213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3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39825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9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597025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2638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098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670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42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14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cl-xS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Picture 2" descr="A screenshot of a computer&#10;&#10;Description automatically generated with low confidence">
              <a:extLst>
                <a:ext uri="{FF2B5EF4-FFF2-40B4-BE49-F238E27FC236}">
                  <a16:creationId xmlns:a16="http://schemas.microsoft.com/office/drawing/2014/main" id="{F11E91F0-BBB9-5949-ED85-75F13E99996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3592" y="4078593"/>
              <a:ext cx="6126511" cy="995558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CF63D90-111D-F1B1-EA55-80C5AF913FA5}"/>
              </a:ext>
            </a:extLst>
          </p:cNvPr>
          <p:cNvSpPr txBox="1"/>
          <p:nvPr/>
        </p:nvSpPr>
        <p:spPr>
          <a:xfrm>
            <a:off x="697831" y="3543618"/>
            <a:ext cx="106278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Example of RT-PCR analysi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x splice isoforms in patients urine samples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NA has been isolated from urine sediments and RT-PCR with specific primers for the tw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x splice isoforms has been performed. </a:t>
            </a: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176703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499811"/>
            <a:ext cx="1062789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. </a:t>
            </a: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ratio from urine sediment does not correlate with serum creatinine rati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cDNA was obtained from RNA extracted from sediments of urine collected from patients overnight. RT-PCR was perform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quantify isoform concentration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calculated. A graph of the Serum creatinine against urinary sedimen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generated using GraphPad prism. The data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Pearson correlation analysis followed by linear regression analysis. (r=0.257, ns p=0.188, N=28 overnight urine samples)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ratio obtained from leucocytes has no correlation with serum creatinine rati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cDNA was obtained from RNA extracted from leucocytes. RTPCR was perform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quantify isoform concentration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calculated. A graph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gainst leucocyt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generated using GraphPad prism.  A Pearson correlation analysis was performed for the data set, including linear regression analysis. (r=0.010, ns p=0.948, N=43 blood samples). Log transformation was used to trans form the data before Pearson correlation was applied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113663" y="11302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6121510" y="63142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9218654"/>
              </p:ext>
            </p:extLst>
          </p:nvPr>
        </p:nvGraphicFramePr>
        <p:xfrm>
          <a:off x="6987295" y="-36221"/>
          <a:ext cx="3783013" cy="270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782505" imgH="2700075" progId="Prism10.Document">
                  <p:embed/>
                </p:oleObj>
              </mc:Choice>
              <mc:Fallback>
                <p:oleObj name="Prism 10" r:id="rId2" imgW="3782505" imgH="270007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87295" y="-36221"/>
                        <a:ext cx="3783013" cy="270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4809638"/>
              </p:ext>
            </p:extLst>
          </p:nvPr>
        </p:nvGraphicFramePr>
        <p:xfrm>
          <a:off x="881397" y="-44728"/>
          <a:ext cx="3770313" cy="270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770261" imgH="2700075" progId="Prism10.Document">
                  <p:embed/>
                </p:oleObj>
              </mc:Choice>
              <mc:Fallback>
                <p:oleObj name="Prism 10" r:id="rId4" imgW="3770261" imgH="270007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81397" y="-44728"/>
                        <a:ext cx="3770313" cy="270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308E0817-F896-D14C-23AA-4CF9EEB599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2474788"/>
              </p:ext>
            </p:extLst>
          </p:nvPr>
        </p:nvGraphicFramePr>
        <p:xfrm>
          <a:off x="1487488" y="2676260"/>
          <a:ext cx="3276600" cy="1781175"/>
        </p:xfrm>
        <a:graphic>
          <a:graphicData uri="http://schemas.openxmlformats.org/drawingml/2006/table">
            <a:tbl>
              <a:tblPr/>
              <a:tblGrid>
                <a:gridCol w="2031492">
                  <a:extLst>
                    <a:ext uri="{9D8B030D-6E8A-4147-A177-3AD203B41FA5}">
                      <a16:colId xmlns:a16="http://schemas.microsoft.com/office/drawing/2014/main" val="3751838134"/>
                    </a:ext>
                  </a:extLst>
                </a:gridCol>
                <a:gridCol w="1245108">
                  <a:extLst>
                    <a:ext uri="{9D8B030D-6E8A-4147-A177-3AD203B41FA5}">
                      <a16:colId xmlns:a16="http://schemas.microsoft.com/office/drawing/2014/main" val="2517000766"/>
                    </a:ext>
                  </a:extLst>
                </a:gridCol>
              </a:tblGrid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4829990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25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4647966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1288 to 0.57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9638617"/>
                  </a:ext>
                </a:extLst>
              </a:tr>
              <a:tr h="5164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65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8354611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757337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0889486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18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9463064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5498600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7174112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841691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7821285"/>
                  </a:ext>
                </a:extLst>
              </a:tr>
            </a:tbl>
          </a:graphicData>
        </a:graphic>
      </p:graphicFrame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7835719"/>
              </p:ext>
            </p:extLst>
          </p:nvPr>
        </p:nvGraphicFramePr>
        <p:xfrm>
          <a:off x="7608888" y="2691376"/>
          <a:ext cx="3276600" cy="1781175"/>
        </p:xfrm>
        <a:graphic>
          <a:graphicData uri="http://schemas.openxmlformats.org/drawingml/2006/table">
            <a:tbl>
              <a:tblPr/>
              <a:tblGrid>
                <a:gridCol w="18945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820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010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3096 to 0.29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0010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94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381954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8084" y="105728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499811"/>
            <a:ext cx="1062789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from urine sediments does not correlate with glycat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aemoglob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cDNA was obtained from RNA extracted from sediments of urine collected from patients overnight. RTPCR was perform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quantify isoform concentration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calculated. A graph of HbA1c against urinary sedimen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generated using GraphPad prism. A Pearson correlation analysis and a linear regression analysis were performed for the data set. (r=-0.065, ns p=0.74, N=28 overnight urine samples)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obtained from leucocytes has no correlation with glycat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aemoglob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cDNA was obtained from RNA extracted from leucocytes. RTPCR was perform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quantify isoform concentration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calculated. A plot of HbA1c against leucocyt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generated using GraphPad prism. Data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sing Pearson correlation analysis and a linear regression analysis was also performed. (r=-0.115, ns p=0.464, N=43 blood samples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79911" y="11331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6096000" y="11331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024130"/>
              </p:ext>
            </p:extLst>
          </p:nvPr>
        </p:nvGraphicFramePr>
        <p:xfrm>
          <a:off x="7010304" y="-49948"/>
          <a:ext cx="3773487" cy="270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773502" imgH="2700075" progId="Prism10.Document">
                  <p:embed/>
                </p:oleObj>
              </mc:Choice>
              <mc:Fallback>
                <p:oleObj name="Prism 10" r:id="rId2" imgW="3773502" imgH="270007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10304" y="-49948"/>
                        <a:ext cx="3773487" cy="270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7476571"/>
              </p:ext>
            </p:extLst>
          </p:nvPr>
        </p:nvGraphicFramePr>
        <p:xfrm>
          <a:off x="897683" y="-55335"/>
          <a:ext cx="3770313" cy="2695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770261" imgH="2695753" progId="Prism10.Document">
                  <p:embed/>
                </p:oleObj>
              </mc:Choice>
              <mc:Fallback>
                <p:oleObj name="Prism 10" r:id="rId4" imgW="3770261" imgH="269575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97683" y="-55335"/>
                        <a:ext cx="3770313" cy="2695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1547455"/>
              </p:ext>
            </p:extLst>
          </p:nvPr>
        </p:nvGraphicFramePr>
        <p:xfrm>
          <a:off x="1487488" y="2704049"/>
          <a:ext cx="3276600" cy="1781175"/>
        </p:xfrm>
        <a:graphic>
          <a:graphicData uri="http://schemas.openxmlformats.org/drawingml/2006/table">
            <a:tbl>
              <a:tblPr/>
              <a:tblGrid>
                <a:gridCol w="20553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127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065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4279 to 0.31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042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74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graphicFrame>
        <p:nvGraphicFramePr>
          <p:cNvPr id="20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8153902"/>
              </p:ext>
            </p:extLst>
          </p:nvPr>
        </p:nvGraphicFramePr>
        <p:xfrm>
          <a:off x="7608888" y="2674156"/>
          <a:ext cx="3275012" cy="1781175"/>
        </p:xfrm>
        <a:graphic>
          <a:graphicData uri="http://schemas.openxmlformats.org/drawingml/2006/table">
            <a:tbl>
              <a:tblPr/>
              <a:tblGrid>
                <a:gridCol w="20543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0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11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4012 to 0.19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13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46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709419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499810"/>
            <a:ext cx="1062789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from urine sediment does not correlate with Fasting Glucose: cDNA was obtained from RNA extracted from sediments of urine collected from patients overnight. RTPCR was perform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quantify isoform concentration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calculated. A plot of Fasting Glucose against urinary sedimen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generated using GraphPad prism. A Pearson correlation was performed as well as a linear regression analysis (r=-0.220, ns p=0.292, N=25 overnight urine samples)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obtained from leucocytes does not correlate with Fasting Glucose rate: cDNA was obtained from RNA extracted from leucocytes. RTPCR was perform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quantify isoform concentration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calculated. A plot of Fasting Glucose against leucocyt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tio was generated using GraphPad prism. A Pearson correlation analysis was performed for the data as well as a linear regression analysis. (r=-0.076, ns p=0.618, N=45 blood samples)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78642" y="9966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6173022" y="9966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275E3C63-25BE-05B8-33AA-D8AF863E6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831" y="9384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CD407350-9602-BF5E-3FDB-F818E1421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377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1933029"/>
              </p:ext>
            </p:extLst>
          </p:nvPr>
        </p:nvGraphicFramePr>
        <p:xfrm>
          <a:off x="7015071" y="-48422"/>
          <a:ext cx="3773487" cy="270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773502" imgH="2700075" progId="Prism10.Document">
                  <p:embed/>
                </p:oleObj>
              </mc:Choice>
              <mc:Fallback>
                <p:oleObj name="Prism 10" r:id="rId2" imgW="3773502" imgH="270007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15071" y="-48422"/>
                        <a:ext cx="3773487" cy="270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1" name="Picture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6874" y="-69445"/>
            <a:ext cx="3780000" cy="2703943"/>
          </a:xfrm>
          <a:prstGeom prst="rect">
            <a:avLst/>
          </a:prstGeom>
        </p:spPr>
      </p:pic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6240900"/>
              </p:ext>
            </p:extLst>
          </p:nvPr>
        </p:nvGraphicFramePr>
        <p:xfrm>
          <a:off x="1487488" y="2690118"/>
          <a:ext cx="3276600" cy="1781175"/>
        </p:xfrm>
        <a:graphic>
          <a:graphicData uri="http://schemas.openxmlformats.org/drawingml/2006/table">
            <a:tbl>
              <a:tblPr/>
              <a:tblGrid>
                <a:gridCol w="20553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127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21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5657 to 0.19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48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29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7009135"/>
              </p:ext>
            </p:extLst>
          </p:nvPr>
        </p:nvGraphicFramePr>
        <p:xfrm>
          <a:off x="7608888" y="2674155"/>
          <a:ext cx="3302000" cy="1781175"/>
        </p:xfrm>
        <a:graphic>
          <a:graphicData uri="http://schemas.openxmlformats.org/drawingml/2006/table">
            <a:tbl>
              <a:tblPr/>
              <a:tblGrid>
                <a:gridCol w="189339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086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076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3619 to 0.22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058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61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07226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4</TotalTime>
  <Words>2295</Words>
  <Application>Microsoft Macintosh PowerPoint</Application>
  <PresentationFormat>Widescreen</PresentationFormat>
  <Paragraphs>162</Paragraphs>
  <Slides>1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tean, Seb</dc:creator>
  <cp:lastModifiedBy>Oltean, Seb</cp:lastModifiedBy>
  <cp:revision>81</cp:revision>
  <dcterms:created xsi:type="dcterms:W3CDTF">2023-11-07T17:41:18Z</dcterms:created>
  <dcterms:modified xsi:type="dcterms:W3CDTF">2025-01-29T17:29:15Z</dcterms:modified>
</cp:coreProperties>
</file>